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1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54FF0A"/>
    <a:srgbClr val="6FFFB3"/>
    <a:srgbClr val="010000"/>
    <a:srgbClr val="FF6B74"/>
    <a:srgbClr val="FFAB38"/>
    <a:srgbClr val="CD3627"/>
    <a:srgbClr val="CD753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302" autoAdjust="0"/>
    <p:restoredTop sz="94479" autoAdjust="0"/>
  </p:normalViewPr>
  <p:slideViewPr>
    <p:cSldViewPr snapToGrid="0">
      <p:cViewPr>
        <p:scale>
          <a:sx n="75" d="100"/>
          <a:sy n="75" d="100"/>
        </p:scale>
        <p:origin x="-2456" y="-256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chong:Desktop:Ron:Publications:2016%20Msmeg%20Cell-free%20system:2016%20Mtb%20Manuscript:FigS4%20raw%20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E$32:$I$32</c:f>
                <c:numCache>
                  <c:formatCode>General</c:formatCode>
                  <c:ptCount val="5"/>
                  <c:pt idx="0">
                    <c:v>1.01833666413985E6</c:v>
                  </c:pt>
                  <c:pt idx="1">
                    <c:v>25.79470229846948</c:v>
                  </c:pt>
                  <c:pt idx="2">
                    <c:v>3763.013141289192</c:v>
                  </c:pt>
                  <c:pt idx="3">
                    <c:v>104.764948548856</c:v>
                  </c:pt>
                  <c:pt idx="4">
                    <c:v>13.10979277741134</c:v>
                  </c:pt>
                </c:numCache>
              </c:numRef>
            </c:plus>
            <c:minus>
              <c:numRef>
                <c:f>Sheet1!$E$32:$I$32</c:f>
                <c:numCache>
                  <c:formatCode>General</c:formatCode>
                  <c:ptCount val="5"/>
                  <c:pt idx="0">
                    <c:v>1.01833666413985E6</c:v>
                  </c:pt>
                  <c:pt idx="1">
                    <c:v>25.79470229846948</c:v>
                  </c:pt>
                  <c:pt idx="2">
                    <c:v>3763.013141289192</c:v>
                  </c:pt>
                  <c:pt idx="3">
                    <c:v>104.764948548856</c:v>
                  </c:pt>
                  <c:pt idx="4">
                    <c:v>13.10979277741134</c:v>
                  </c:pt>
                </c:numCache>
              </c:numRef>
            </c:minus>
          </c:errBars>
          <c:val>
            <c:numRef>
              <c:f>Sheet1!$E$31:$I$31</c:f>
              <c:numCache>
                <c:formatCode>General</c:formatCode>
                <c:ptCount val="5"/>
                <c:pt idx="0">
                  <c:v>1.46054125E6</c:v>
                </c:pt>
                <c:pt idx="1">
                  <c:v>526.1666666666666</c:v>
                </c:pt>
                <c:pt idx="2">
                  <c:v>4016.916666666667</c:v>
                </c:pt>
                <c:pt idx="3">
                  <c:v>409.2222222222222</c:v>
                </c:pt>
                <c:pt idx="4">
                  <c:v>160.33333333333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5559080"/>
        <c:axId val="2125562440"/>
      </c:barChart>
      <c:catAx>
        <c:axId val="212555908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125562440"/>
        <c:crosses val="autoZero"/>
        <c:auto val="1"/>
        <c:lblAlgn val="ctr"/>
        <c:lblOffset val="100"/>
        <c:noMultiLvlLbl val="0"/>
      </c:catAx>
      <c:valAx>
        <c:axId val="2125562440"/>
        <c:scaling>
          <c:logBase val="10.0"/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12555908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txPr>
    <a:bodyPr/>
    <a:lstStyle/>
    <a:p>
      <a:pPr>
        <a:defRPr sz="1200">
          <a:latin typeface="Times New Roman"/>
          <a:cs typeface="Times New Roman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B796EE0-5211-8D43-85F0-F384DCFDB57E}" type="datetimeFigureOut">
              <a:rPr lang="en-US" smtClean="0"/>
              <a:t>8/19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9395AA-AA7E-EF48-902C-80DB616617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17567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9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9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5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5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TextBox 82"/>
          <p:cNvSpPr txBox="1"/>
          <p:nvPr/>
        </p:nvSpPr>
        <p:spPr>
          <a:xfrm>
            <a:off x="1827769" y="4644976"/>
            <a:ext cx="391026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latin typeface="Times New Roman"/>
                <a:cs typeface="Times New Roman"/>
              </a:rPr>
              <a:t>tRNAs</a:t>
            </a:r>
            <a:r>
              <a:rPr lang="en-US" sz="1200" dirty="0" smtClean="0">
                <a:latin typeface="Times New Roman"/>
                <a:cs typeface="Times New Roman"/>
              </a:rPr>
              <a:t>		+	    +	         -             -	   +</a:t>
            </a:r>
          </a:p>
          <a:p>
            <a:r>
              <a:rPr lang="en-US" sz="1200" dirty="0" smtClean="0">
                <a:latin typeface="Times New Roman"/>
                <a:cs typeface="Times New Roman"/>
              </a:rPr>
              <a:t>AARSs	+              -               +             -	   +</a:t>
            </a:r>
          </a:p>
          <a:p>
            <a:r>
              <a:rPr lang="en-US" sz="1200" dirty="0" smtClean="0">
                <a:latin typeface="Times New Roman"/>
                <a:cs typeface="Times New Roman"/>
              </a:rPr>
              <a:t>TFs		+              +              +             +	   -</a:t>
            </a:r>
          </a:p>
          <a:p>
            <a:r>
              <a:rPr lang="en-US" sz="1200" dirty="0" smtClean="0">
                <a:latin typeface="Times New Roman"/>
                <a:cs typeface="Times New Roman"/>
              </a:rPr>
              <a:t>Ribosomes	</a:t>
            </a:r>
            <a:r>
              <a:rPr lang="en-US" sz="1200" dirty="0">
                <a:latin typeface="Times New Roman"/>
                <a:cs typeface="Times New Roman"/>
              </a:rPr>
              <a:t>+              +              </a:t>
            </a:r>
            <a:r>
              <a:rPr lang="en-US" sz="1200" dirty="0" smtClean="0">
                <a:latin typeface="Times New Roman"/>
                <a:cs typeface="Times New Roman"/>
              </a:rPr>
              <a:t>+             +	   +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84" name="Rectangle 83"/>
          <p:cNvSpPr/>
          <p:nvPr/>
        </p:nvSpPr>
        <p:spPr>
          <a:xfrm rot="16200000">
            <a:off x="546557" y="3509090"/>
            <a:ext cx="1877437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Luciferase reporter activity </a:t>
            </a:r>
          </a:p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(relative light units)</a:t>
            </a:r>
            <a:endParaRPr lang="en-US" sz="1200" dirty="0"/>
          </a:p>
        </p:txBody>
      </p:sp>
      <p:graphicFrame>
        <p:nvGraphicFramePr>
          <p:cNvPr id="85" name="Chart 8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39103275"/>
              </p:ext>
            </p:extLst>
          </p:nvPr>
        </p:nvGraphicFramePr>
        <p:xfrm>
          <a:off x="1769323" y="2646414"/>
          <a:ext cx="3942248" cy="20974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75612047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392</TotalTime>
  <Words>9</Words>
  <Application>Microsoft Macintosh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hong neb</dc:creator>
  <cp:lastModifiedBy>chong neb</cp:lastModifiedBy>
  <cp:revision>309</cp:revision>
  <cp:lastPrinted>2015-10-14T16:25:31Z</cp:lastPrinted>
  <dcterms:created xsi:type="dcterms:W3CDTF">2011-06-03T13:51:04Z</dcterms:created>
  <dcterms:modified xsi:type="dcterms:W3CDTF">2016-08-19T14:26:58Z</dcterms:modified>
</cp:coreProperties>
</file>